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23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300"/>
    <a:srgbClr val="0432FF"/>
    <a:srgbClr val="FF0100"/>
    <a:srgbClr val="FF9700"/>
    <a:srgbClr val="FEFF1C"/>
    <a:srgbClr val="FFB502"/>
    <a:srgbClr val="FFD302"/>
    <a:srgbClr val="FCB301"/>
    <a:srgbClr val="F69102"/>
    <a:srgbClr val="FFFF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13"/>
    <p:restoredTop sz="95161"/>
  </p:normalViewPr>
  <p:slideViewPr>
    <p:cSldViewPr snapToGrid="0" snapToObjects="1">
      <p:cViewPr varScale="1">
        <p:scale>
          <a:sx n="55" d="100"/>
          <a:sy n="55" d="100"/>
        </p:scale>
        <p:origin x="3144" y="19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>
            <a:extLst>
              <a:ext uri="{FF2B5EF4-FFF2-40B4-BE49-F238E27FC236}">
                <a16:creationId xmlns:a16="http://schemas.microsoft.com/office/drawing/2014/main" id="{40043BCA-F8B5-355A-E4E8-652C6966EF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914" y="1143772"/>
            <a:ext cx="3683135" cy="3273898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4D3FB7F5-11DB-777C-E07D-14BB41F87A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0422" y="1173165"/>
            <a:ext cx="2715050" cy="1634302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705670E6-CA8D-C547-EBD0-A25AFD06E0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90422" y="2995454"/>
            <a:ext cx="2715050" cy="1694745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E66C9E7D-8FB5-CCEB-4851-09329FFC59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94339" y="4985053"/>
            <a:ext cx="2611133" cy="1544920"/>
          </a:xfrm>
          <a:prstGeom prst="rect">
            <a:avLst/>
          </a:prstGeom>
        </p:spPr>
      </p:pic>
      <p:pic>
        <p:nvPicPr>
          <p:cNvPr id="124" name="Picture 123">
            <a:extLst>
              <a:ext uri="{FF2B5EF4-FFF2-40B4-BE49-F238E27FC236}">
                <a16:creationId xmlns:a16="http://schemas.microsoft.com/office/drawing/2014/main" id="{786CC722-0DBF-ED1E-3C60-DC23D01F59C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44385" y="1070766"/>
            <a:ext cx="1673158" cy="1800556"/>
          </a:xfrm>
          <a:prstGeom prst="rect">
            <a:avLst/>
          </a:prstGeom>
        </p:spPr>
      </p:pic>
      <p:pic>
        <p:nvPicPr>
          <p:cNvPr id="125" name="Picture 124">
            <a:extLst>
              <a:ext uri="{FF2B5EF4-FFF2-40B4-BE49-F238E27FC236}">
                <a16:creationId xmlns:a16="http://schemas.microsoft.com/office/drawing/2014/main" id="{02599EAC-EDBD-73E3-67A9-F3D8AD8B26C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50579" y="2921120"/>
            <a:ext cx="1766104" cy="1694746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6FCF8A39-25CF-EF41-3027-F96B343889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44385" y="4850746"/>
            <a:ext cx="1814951" cy="1901791"/>
          </a:xfrm>
          <a:prstGeom prst="rect">
            <a:avLst/>
          </a:prstGeom>
        </p:spPr>
      </p:pic>
      <p:pic>
        <p:nvPicPr>
          <p:cNvPr id="134" name="Picture 133">
            <a:extLst>
              <a:ext uri="{FF2B5EF4-FFF2-40B4-BE49-F238E27FC236}">
                <a16:creationId xmlns:a16="http://schemas.microsoft.com/office/drawing/2014/main" id="{FE1FE730-A0EF-5C2A-2A53-E42BE7EEB79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68642" y="4718168"/>
            <a:ext cx="2764970" cy="2409597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id="{BDC38440-07D4-34C0-2951-44BE8F92DEC4}"/>
              </a:ext>
            </a:extLst>
          </p:cNvPr>
          <p:cNvSpPr txBox="1"/>
          <p:nvPr/>
        </p:nvSpPr>
        <p:spPr>
          <a:xfrm>
            <a:off x="403507" y="7284588"/>
            <a:ext cx="919769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Changes in external appearance of mature green “Moneymaker” tomato fruits during storage at 20 and 5ºC with or without 1-methylcyclopropene (1-MCP) treatment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external appearance during storage at 20ºC and 5ºC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nges in CIELAB color parameter a*. Each datapoint represents the average (± SE) of 6 fruit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earance and chilling injury index after 7 d at 20ºC following storage at 5ºC for 7, 14 and 21 d. Each datapoint represents the average (± SE) of 10 fruit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ling injury index in fruit during storage at 20ºC following 14 d at 5ºC. Each column represents the average (± SE) of 10 frui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fruit showing uneven ripening and surface pitting after storage at 5ºC, and decay with surface pitting in 1-MCP treated fruit. Fruit were stored at 5ºC for 14 d followed by post-cold shelf life at 20ºC for 7 d. Different letters indicate significant differences in ANOVA (Tukey’s test,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DD40CFB1-CBDF-7256-0466-7FBADCD445C2}"/>
              </a:ext>
            </a:extLst>
          </p:cNvPr>
          <p:cNvSpPr txBox="1"/>
          <p:nvPr/>
        </p:nvSpPr>
        <p:spPr>
          <a:xfrm>
            <a:off x="423879" y="970407"/>
            <a:ext cx="441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A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3BC8403-0850-9C85-72ED-B26F38686A6E}"/>
              </a:ext>
            </a:extLst>
          </p:cNvPr>
          <p:cNvSpPr txBox="1"/>
          <p:nvPr/>
        </p:nvSpPr>
        <p:spPr>
          <a:xfrm>
            <a:off x="829984" y="4518113"/>
            <a:ext cx="441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B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8F7239C7-8FA0-DA05-2DCC-A15A518A60D1}"/>
              </a:ext>
            </a:extLst>
          </p:cNvPr>
          <p:cNvSpPr txBox="1"/>
          <p:nvPr/>
        </p:nvSpPr>
        <p:spPr>
          <a:xfrm>
            <a:off x="4622887" y="973232"/>
            <a:ext cx="441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47375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48</TotalTime>
  <Words>197</Words>
  <Application>Microsoft Macintosh PowerPoint</Application>
  <PresentationFormat>A3 Paper (297x420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 Neue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664</cp:revision>
  <cp:lastPrinted>2022-02-28T04:45:31Z</cp:lastPrinted>
  <dcterms:created xsi:type="dcterms:W3CDTF">2018-04-12T04:09:11Z</dcterms:created>
  <dcterms:modified xsi:type="dcterms:W3CDTF">2023-07-11T15:16:06Z</dcterms:modified>
  <cp:category/>
</cp:coreProperties>
</file>